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2" autoAdjust="0"/>
    <p:restoredTop sz="94660"/>
  </p:normalViewPr>
  <p:slideViewPr>
    <p:cSldViewPr snapToGrid="0">
      <p:cViewPr>
        <p:scale>
          <a:sx n="90" d="100"/>
          <a:sy n="90" d="100"/>
        </p:scale>
        <p:origin x="-108" y="-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1900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6537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752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2792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9449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2553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5868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201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0758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14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0033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A87AC5-BB38-422F-8B6E-7EB8C34E058E}" type="datetimeFigureOut">
              <a:rPr lang="en-GB" smtClean="0"/>
              <a:t>23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78248-5422-4CED-96EE-692E9AB9E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8393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972" y="557231"/>
            <a:ext cx="11535037" cy="457624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6042" y="5775158"/>
            <a:ext cx="12192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stopathogical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alysis of </a:t>
            </a:r>
            <a:r>
              <a:rPr lang="en-GB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G. </a:t>
            </a:r>
            <a:r>
              <a:rPr lang="en-GB" sz="11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llonella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arvae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– negative controls. 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larval groups for comparison with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vis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CG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ux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fected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. 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llonella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cluded an uninfected (pricked) larval group (n=3) and a PBS only (10 µl) challenged larval group (n=3) for each 24 h </a:t>
            </a:r>
            <a:r>
              <a:rPr lang="en-GB" sz="1100" smtClean="0">
                <a:latin typeface="Arial" panose="020B0604020202020204" pitchFamily="34" charset="0"/>
                <a:cs typeface="Arial" panose="020B0604020202020204" pitchFamily="34" charset="0"/>
              </a:rPr>
              <a:t>time-point </a:t>
            </a:r>
            <a:r>
              <a:rPr lang="en-GB" sz="1100" smtClean="0">
                <a:latin typeface="Arial" panose="020B0604020202020204" pitchFamily="34" charset="0"/>
                <a:cs typeface="Arial" panose="020B0604020202020204" pitchFamily="34" charset="0"/>
              </a:rPr>
              <a:t>over a 96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 period.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GB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vis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CG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ux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fected and uninfected control group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arvae were fixed by injecting 100 µl of buffered formalin with an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sulin syring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nto the last left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roleg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</a:p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uninfecte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(pricked) larvae (A) or larva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hallenge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ith PBS (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) at 96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ost-challenge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no ZN bacilli or granulomas were detected.  Scale bar represents 1000 µm; fb, fat body.  </a:t>
            </a:r>
          </a:p>
          <a:p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2979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37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wton, Sandra M</dc:creator>
  <cp:lastModifiedBy>Newton, Sandra M</cp:lastModifiedBy>
  <cp:revision>5</cp:revision>
  <dcterms:created xsi:type="dcterms:W3CDTF">2018-03-23T20:28:25Z</dcterms:created>
  <dcterms:modified xsi:type="dcterms:W3CDTF">2018-03-23T20:51:11Z</dcterms:modified>
</cp:coreProperties>
</file>